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75" r:id="rId1"/>
  </p:sldMasterIdLst>
  <p:notesMasterIdLst>
    <p:notesMasterId r:id="rId4"/>
  </p:notesMasterIdLst>
  <p:sldIdLst>
    <p:sldId id="422" r:id="rId2"/>
    <p:sldId id="42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thleen Fisch" initials="KMF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FF"/>
    <a:srgbClr val="EAEFF7"/>
    <a:srgbClr val="D2DEEF"/>
    <a:srgbClr val="54BDD5"/>
    <a:srgbClr val="AAC56C"/>
    <a:srgbClr val="52A0BD"/>
    <a:srgbClr val="1F497D"/>
    <a:srgbClr val="FFC000"/>
    <a:srgbClr val="C0504D"/>
    <a:srgbClr val="C059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339"/>
    <p:restoredTop sz="91611"/>
  </p:normalViewPr>
  <p:slideViewPr>
    <p:cSldViewPr snapToGrid="0" snapToObjects="1">
      <p:cViewPr varScale="1">
        <p:scale>
          <a:sx n="120" d="100"/>
          <a:sy n="120" d="100"/>
        </p:scale>
        <p:origin x="2408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A0B351-BE0E-FF47-B62D-606877D97EC4}" type="datetimeFigureOut">
              <a:rPr lang="en-US" smtClean="0"/>
              <a:t>10/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BF178-9021-424A-82C6-DA9D588ABA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992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BDA7-7D8D-164A-B372-1DCD7383FD38}" type="datetime1">
              <a:rPr lang="en-US" smtClean="0"/>
              <a:t>10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770261"/>
      </p:ext>
    </p:extLst>
  </p:cSld>
  <p:clrMapOvr>
    <a:masterClrMapping/>
  </p:clrMapOvr>
  <p:extLst mod="1">
    <p:ext uri="{DCECCB84-F9BA-43D5-87BE-67443E8EF086}">
      <p15:sldGuideLst xmlns:p15="http://schemas.microsoft.com/office/powerpoint/2012/main"/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FC032-B88C-E946-A53F-1027342632A6}" type="datetime1">
              <a:rPr lang="en-US" smtClean="0"/>
              <a:t>10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68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FDCCD-CB70-A341-BCC3-21F0C0D96913}" type="datetime1">
              <a:rPr lang="en-US" smtClean="0"/>
              <a:t>10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489405"/>
      </p:ext>
    </p:extLst>
  </p:cSld>
  <p:clrMapOvr>
    <a:masterClrMapping/>
  </p:clrMapOvr>
  <p:extLst mod="1">
    <p:ext uri="{DCECCB84-F9BA-43D5-87BE-67443E8EF086}">
      <p15:sldGuideLst xmlns:p15="http://schemas.microsoft.com/office/powerpoint/2012/main"/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B88E2-81C2-224B-802B-8CB7ECFBD987}" type="datetime1">
              <a:rPr lang="en-US" smtClean="0"/>
              <a:t>10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607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6F83-6AF6-A242-811A-C5CB320A2548}" type="datetime1">
              <a:rPr lang="en-US" smtClean="0"/>
              <a:t>10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21923"/>
      </p:ext>
    </p:extLst>
  </p:cSld>
  <p:clrMapOvr>
    <a:masterClrMapping/>
  </p:clrMapOvr>
  <p:extLst mod="1">
    <p:ext uri="{DCECCB84-F9BA-43D5-87BE-67443E8EF086}">
      <p15:sldGuideLst xmlns:p15="http://schemas.microsoft.com/office/powerpoint/2012/main"/>
    </p:ext>
  </p:extLs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80DF8-4C10-9A41-80C0-AAFC97705942}" type="datetime1">
              <a:rPr lang="en-US" smtClean="0"/>
              <a:t>10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245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C51EA-8826-644E-B3BC-FAC100C026CE}" type="datetime1">
              <a:rPr lang="en-US" smtClean="0"/>
              <a:t>10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036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1755-8CD3-554D-9E11-3831B33E9906}" type="datetime1">
              <a:rPr lang="en-US" smtClean="0"/>
              <a:t>10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244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10DBC-7AA4-E942-9908-15C303FE248F}" type="datetime1">
              <a:rPr lang="en-US" smtClean="0"/>
              <a:t>10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58583"/>
      </p:ext>
    </p:extLst>
  </p:cSld>
  <p:clrMapOvr>
    <a:masterClrMapping/>
  </p:clrMapOvr>
  <p:extLst mod="1">
    <p:ext uri="{DCECCB84-F9BA-43D5-87BE-67443E8EF086}">
      <p15:sldGuideLst xmlns:p15="http://schemas.microsoft.com/office/powerpoint/2012/main"/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6F47E-6723-1540-9DF1-3302668516FF}" type="datetime1">
              <a:rPr lang="en-US" smtClean="0"/>
              <a:t>10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9333"/>
      </p:ext>
    </p:extLst>
  </p:cSld>
  <p:clrMapOvr>
    <a:masterClrMapping/>
  </p:clrMapOvr>
  <p:extLst mod="1">
    <p:ext uri="{DCECCB84-F9BA-43D5-87BE-67443E8EF086}">
      <p15:sldGuideLst xmlns:p15="http://schemas.microsoft.com/office/powerpoint/2012/main"/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F89DF-1C9C-EF47-8971-167F32B065D4}" type="datetime1">
              <a:rPr lang="en-US" smtClean="0"/>
              <a:t>10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37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9F8D6-5ABE-3043-A584-435929FFBBCB}" type="datetime1">
              <a:rPr lang="en-US" smtClean="0"/>
              <a:t>10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115B6-0331-AA4D-A5B5-C042677FE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31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76" r:id="rId1"/>
    <p:sldLayoutId id="2147483877" r:id="rId2"/>
    <p:sldLayoutId id="2147483878" r:id="rId3"/>
    <p:sldLayoutId id="2147483879" r:id="rId4"/>
    <p:sldLayoutId id="2147483880" r:id="rId5"/>
    <p:sldLayoutId id="2147483881" r:id="rId6"/>
    <p:sldLayoutId id="2147483882" r:id="rId7"/>
    <p:sldLayoutId id="2147483883" r:id="rId8"/>
    <p:sldLayoutId id="2147483884" r:id="rId9"/>
    <p:sldLayoutId id="2147483885" r:id="rId10"/>
    <p:sldLayoutId id="2147483886" r:id="rId11"/>
  </p:sldLayoutIdLst>
  <p:hf sldNum="0"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1FEDD-ED08-4E44-B1F7-E8B89399B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4092" y="157634"/>
            <a:ext cx="6331351" cy="779460"/>
          </a:xfrm>
        </p:spPr>
        <p:txBody>
          <a:bodyPr>
            <a:normAutofit fontScale="90000"/>
          </a:bodyPr>
          <a:lstStyle/>
          <a:p>
            <a:r>
              <a:rPr lang="en-US" dirty="0"/>
              <a:t>30 Proteins with Ubiquitinated Peptides</a:t>
            </a: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BE142B-E387-7F46-95D6-FCF6585B6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CDCB104-418A-F040-9265-31AEBCB1F814}"/>
              </a:ext>
            </a:extLst>
          </p:cNvPr>
          <p:cNvGrpSpPr/>
          <p:nvPr/>
        </p:nvGrpSpPr>
        <p:grpSpPr>
          <a:xfrm>
            <a:off x="228600" y="6292489"/>
            <a:ext cx="8686800" cy="579625"/>
            <a:chOff x="228600" y="6280914"/>
            <a:chExt cx="8686800" cy="57962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D434972-C1C3-B149-9639-C0E4F1F1AB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6311899"/>
              <a:ext cx="2731820" cy="54864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D507B45-859C-0A4A-8CC2-1F58B3A9DE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38685" y="6309360"/>
              <a:ext cx="1683759" cy="548640"/>
            </a:xfrm>
            <a:prstGeom prst="rect">
              <a:avLst/>
            </a:prstGeom>
          </p:spPr>
        </p:pic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18154B19-0682-9B45-8675-AF55C386ED95}"/>
                </a:ext>
              </a:extLst>
            </p:cNvPr>
            <p:cNvCxnSpPr/>
            <p:nvPr/>
          </p:nvCxnSpPr>
          <p:spPr>
            <a:xfrm>
              <a:off x="228600" y="6280914"/>
              <a:ext cx="8686800" cy="0"/>
            </a:xfrm>
            <a:prstGeom prst="line">
              <a:avLst/>
            </a:prstGeom>
            <a:ln w="28575">
              <a:solidFill>
                <a:schemeClr val="accent4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9EAFA6F8-AAEA-6A4E-B3F7-7C423CCDD1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748788"/>
              </p:ext>
            </p:extLst>
          </p:nvPr>
        </p:nvGraphicFramePr>
        <p:xfrm>
          <a:off x="324092" y="1404443"/>
          <a:ext cx="8122190" cy="4476008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778803">
                  <a:extLst>
                    <a:ext uri="{9D8B030D-6E8A-4147-A177-3AD203B41FA5}">
                      <a16:colId xmlns:a16="http://schemas.microsoft.com/office/drawing/2014/main" val="3976302388"/>
                    </a:ext>
                  </a:extLst>
                </a:gridCol>
                <a:gridCol w="724544">
                  <a:extLst>
                    <a:ext uri="{9D8B030D-6E8A-4147-A177-3AD203B41FA5}">
                      <a16:colId xmlns:a16="http://schemas.microsoft.com/office/drawing/2014/main" val="1752430893"/>
                    </a:ext>
                  </a:extLst>
                </a:gridCol>
                <a:gridCol w="2932368">
                  <a:extLst>
                    <a:ext uri="{9D8B030D-6E8A-4147-A177-3AD203B41FA5}">
                      <a16:colId xmlns:a16="http://schemas.microsoft.com/office/drawing/2014/main" val="4200626102"/>
                    </a:ext>
                  </a:extLst>
                </a:gridCol>
                <a:gridCol w="2098307">
                  <a:extLst>
                    <a:ext uri="{9D8B030D-6E8A-4147-A177-3AD203B41FA5}">
                      <a16:colId xmlns:a16="http://schemas.microsoft.com/office/drawing/2014/main" val="3566788980"/>
                    </a:ext>
                  </a:extLst>
                </a:gridCol>
                <a:gridCol w="1588168">
                  <a:extLst>
                    <a:ext uri="{9D8B030D-6E8A-4147-A177-3AD203B41FA5}">
                      <a16:colId xmlns:a16="http://schemas.microsoft.com/office/drawing/2014/main" val="911879502"/>
                    </a:ext>
                  </a:extLst>
                </a:gridCol>
              </a:tblGrid>
              <a:tr h="5705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</a:rPr>
                        <a:t>UniProt</a:t>
                      </a:r>
                      <a:r>
                        <a:rPr lang="en-US" sz="1400" u="none" strike="noStrike" dirty="0">
                          <a:effectLst/>
                        </a:rPr>
                        <a:t> I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Gene Nam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Descriptio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WT Samples w/Peptides – Pep #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K171E 9KR Samples w/Peptides – Pep #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71267788"/>
                  </a:ext>
                </a:extLst>
              </a:tr>
              <a:tr h="1956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P149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IDO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Indoleamine</a:t>
                      </a:r>
                      <a:r>
                        <a:rPr lang="en-US" sz="1200" u="none" strike="noStrike" dirty="0">
                          <a:effectLst/>
                        </a:rPr>
                        <a:t> 2,3-dioxygenas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09181564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P611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ZC3H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Zinc finger CCCH domain-containing protein 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16150920"/>
                  </a:ext>
                </a:extLst>
              </a:tr>
              <a:tr h="1956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03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D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Dyston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76960420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2KHR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SER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Glutamine and serine-rich protein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64068223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4G0P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YD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ydrocephalus-inducing protein homolo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89892990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7Z57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SPATA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Spermatogenesis-associated protein 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70943048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86U0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RBM2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Probable RNA-binding protein 2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07737582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8IWV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UBR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E3 ubiquitin-protein ligase UBR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70521844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96RS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UDC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NudC</a:t>
                      </a:r>
                      <a:r>
                        <a:rPr lang="en-US" sz="1200" u="none" strike="noStrike" dirty="0">
                          <a:effectLst/>
                        </a:rPr>
                        <a:t> domain-containing protein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04122037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Q9NWS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PIH1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PIH1 domain-containing protein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01327159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9994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F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3 ubiquitin-protein ligase RNF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07416663"/>
                  </a:ext>
                </a:extLst>
              </a:tr>
              <a:tr h="3108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9GZS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R1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-directed RNA polymerase I subunit RPA4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95348197"/>
                  </a:ext>
                </a:extLst>
              </a:tr>
              <a:tr h="2096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9NS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3 ubiquitin-protein ligase RAD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- 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28991936"/>
                  </a:ext>
                </a:extLst>
              </a:tr>
              <a:tr h="1956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9UNZ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FL1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FL1 cofactor p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621823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4921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1FEDD-ED08-4E44-B1F7-E8B89399B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4092" y="157634"/>
            <a:ext cx="6331351" cy="779460"/>
          </a:xfrm>
        </p:spPr>
        <p:txBody>
          <a:bodyPr>
            <a:normAutofit fontScale="90000"/>
          </a:bodyPr>
          <a:lstStyle/>
          <a:p>
            <a:r>
              <a:rPr lang="en-US" dirty="0"/>
              <a:t>30 Proteins with Ubiquitinated Peptides (continued)</a:t>
            </a: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BE142B-E387-7F46-95D6-FCF6585B6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CDCB104-418A-F040-9265-31AEBCB1F814}"/>
              </a:ext>
            </a:extLst>
          </p:cNvPr>
          <p:cNvGrpSpPr/>
          <p:nvPr/>
        </p:nvGrpSpPr>
        <p:grpSpPr>
          <a:xfrm>
            <a:off x="228600" y="6292489"/>
            <a:ext cx="8686800" cy="579625"/>
            <a:chOff x="228600" y="6280914"/>
            <a:chExt cx="8686800" cy="57962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D434972-C1C3-B149-9639-C0E4F1F1AB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6311899"/>
              <a:ext cx="2731820" cy="54864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D507B45-859C-0A4A-8CC2-1F58B3A9DE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38685" y="6309360"/>
              <a:ext cx="1683759" cy="548640"/>
            </a:xfrm>
            <a:prstGeom prst="rect">
              <a:avLst/>
            </a:prstGeom>
          </p:spPr>
        </p:pic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18154B19-0682-9B45-8675-AF55C386ED95}"/>
                </a:ext>
              </a:extLst>
            </p:cNvPr>
            <p:cNvCxnSpPr/>
            <p:nvPr/>
          </p:nvCxnSpPr>
          <p:spPr>
            <a:xfrm>
              <a:off x="228600" y="6280914"/>
              <a:ext cx="8686800" cy="0"/>
            </a:xfrm>
            <a:prstGeom prst="line">
              <a:avLst/>
            </a:prstGeom>
            <a:ln w="28575">
              <a:solidFill>
                <a:schemeClr val="accent4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BEE18337-93CD-9948-A515-CE5F207B89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741480"/>
              </p:ext>
            </p:extLst>
          </p:nvPr>
        </p:nvGraphicFramePr>
        <p:xfrm>
          <a:off x="744983" y="1393259"/>
          <a:ext cx="7505089" cy="461015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771245">
                  <a:extLst>
                    <a:ext uri="{9D8B030D-6E8A-4147-A177-3AD203B41FA5}">
                      <a16:colId xmlns:a16="http://schemas.microsoft.com/office/drawing/2014/main" val="3976302388"/>
                    </a:ext>
                  </a:extLst>
                </a:gridCol>
                <a:gridCol w="625665">
                  <a:extLst>
                    <a:ext uri="{9D8B030D-6E8A-4147-A177-3AD203B41FA5}">
                      <a16:colId xmlns:a16="http://schemas.microsoft.com/office/drawing/2014/main" val="1230396704"/>
                    </a:ext>
                  </a:extLst>
                </a:gridCol>
                <a:gridCol w="2738116">
                  <a:extLst>
                    <a:ext uri="{9D8B030D-6E8A-4147-A177-3AD203B41FA5}">
                      <a16:colId xmlns:a16="http://schemas.microsoft.com/office/drawing/2014/main" val="1752430893"/>
                    </a:ext>
                  </a:extLst>
                </a:gridCol>
                <a:gridCol w="1694046">
                  <a:extLst>
                    <a:ext uri="{9D8B030D-6E8A-4147-A177-3AD203B41FA5}">
                      <a16:colId xmlns:a16="http://schemas.microsoft.com/office/drawing/2014/main" val="1642495156"/>
                    </a:ext>
                  </a:extLst>
                </a:gridCol>
                <a:gridCol w="1676017">
                  <a:extLst>
                    <a:ext uri="{9D8B030D-6E8A-4147-A177-3AD203B41FA5}">
                      <a16:colId xmlns:a16="http://schemas.microsoft.com/office/drawing/2014/main" val="2828674168"/>
                    </a:ext>
                  </a:extLst>
                </a:gridCol>
              </a:tblGrid>
              <a:tr h="52920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</a:rPr>
                        <a:t>UniProt</a:t>
                      </a:r>
                      <a:r>
                        <a:rPr lang="en-US" sz="1400" u="none" strike="noStrike" dirty="0">
                          <a:effectLst/>
                        </a:rPr>
                        <a:t> I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Gene Nam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Descriptio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WT Samples w/Peptides – Pep #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K171E 9KR Samples w/Peptides – Pep #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71267788"/>
                  </a:ext>
                </a:extLst>
              </a:tr>
              <a:tr h="3770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148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AMP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cretory carrier-associated membrane protein 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49420744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604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X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rting nexin-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09181564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751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JB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J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homolog subfamily B member 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16150920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064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K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clin-dependent kinase 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76960420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151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tamine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nthet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64068223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459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SP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iquitin carboxyl-terminal hydrolase 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89892990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5585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MO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all ubiquitin-related modifier 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- 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- 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70943048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610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E2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iquitin-conjugating enzyme E2 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07737582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631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MO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all ubiquitin-related modifier 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70521844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043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XN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X domain-containing protein 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04122037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135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QSTM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questosome-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01327159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157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C1A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tral amino acid transporter B(0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65635488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158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DD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DD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24585537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168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P51A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nostero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14-alpha demethylas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- 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- 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6164973"/>
                  </a:ext>
                </a:extLst>
              </a:tr>
              <a:tr h="2645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96GF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NF1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3 ubiquitin-protein ligase RNF1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- 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- 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426226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57456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isch_CCBB_Introduction_20170227" id="{E8932A44-D5CA-B943-B40B-32F608EB9312}" vid="{7D311206-5182-D24E-9CFB-2BFC680FFD4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ccbb</Template>
  <TotalTime>62122</TotalTime>
  <Words>396</Words>
  <Application>Microsoft Macintosh PowerPoint</Application>
  <PresentationFormat>On-screen Show (4:3)</PresentationFormat>
  <Paragraphs>15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30 Proteins with Ubiquitinated Peptides</vt:lpstr>
      <vt:lpstr>30 Proteins with Ubiquitinated Peptides (continued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troduction to the UCSD Center for Computational Biology &amp; Bioinformatics</dc:title>
  <dc:creator>Kathleen Fisch</dc:creator>
  <cp:lastModifiedBy>Donoghue, Daniel</cp:lastModifiedBy>
  <cp:revision>173</cp:revision>
  <dcterms:created xsi:type="dcterms:W3CDTF">2017-07-10T18:29:00Z</dcterms:created>
  <dcterms:modified xsi:type="dcterms:W3CDTF">2018-10-09T19:10:19Z</dcterms:modified>
</cp:coreProperties>
</file>